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AC3F7-9E17-4589-8F7D-B0412B5093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DC4A7-2633-4A6A-A628-27C4922A87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E8212-3FB8-48F8-BD26-E22C7855DB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2058B-174B-4F26-96BD-6177AA3673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8FD0E-DE81-42DD-8D24-94CC838106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7D57B-C996-4F96-BD4C-A6C465B136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C6D6A-6DD8-479D-9CD5-19CCF745EB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8239F-7AEB-4AE2-AA5F-676430B54F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2F14D-9963-49FA-BCE0-370E575230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5B140-B535-454A-85A6-88CD81218F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161CB-5B69-4266-B87E-522AB87831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5C9A2-80A3-4A4F-9C98-10373354E1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E3FD169-8EFE-42CB-ABBC-E3D472AA26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6975" t="2475" r="3006" b="2610"/>
          <a:stretch/>
        </p:blipFill>
        <p:spPr>
          <a:xfrm>
            <a:off x="3568680" y="2689200"/>
            <a:ext cx="1811520" cy="18115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0" t="0" r="9420" b="0"/>
          <a:stretch/>
        </p:blipFill>
        <p:spPr>
          <a:xfrm>
            <a:off x="5591160" y="2684520"/>
            <a:ext cx="1811520" cy="1812960"/>
          </a:xfrm>
          <a:prstGeom prst="rect">
            <a:avLst/>
          </a:prstGeom>
          <a:ln w="0">
            <a:noFill/>
          </a:ln>
        </p:spPr>
      </p:pic>
      <p:sp>
        <p:nvSpPr>
          <p:cNvPr id="43" name="TextBox 10"/>
          <p:cNvSpPr/>
          <p:nvPr/>
        </p:nvSpPr>
        <p:spPr>
          <a:xfrm>
            <a:off x="3861360" y="2289240"/>
            <a:ext cx="1244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rg81Δ/Δ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0"/>
          <p:cNvSpPr/>
          <p:nvPr/>
        </p:nvSpPr>
        <p:spPr>
          <a:xfrm>
            <a:off x="5844240" y="2004840"/>
            <a:ext cx="130680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rg81Δ/Δ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+pARG8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7" descr=""/>
          <p:cNvPicPr/>
          <p:nvPr/>
        </p:nvPicPr>
        <p:blipFill>
          <a:blip r:embed="rId3"/>
          <a:srcRect l="0" t="10515" r="8362" b="2618"/>
          <a:stretch/>
        </p:blipFill>
        <p:spPr>
          <a:xfrm>
            <a:off x="1536840" y="2684520"/>
            <a:ext cx="1819080" cy="1820880"/>
          </a:xfrm>
          <a:prstGeom prst="rect">
            <a:avLst/>
          </a:prstGeom>
          <a:ln w="0">
            <a:noFill/>
          </a:ln>
        </p:spPr>
      </p:pic>
      <p:sp>
        <p:nvSpPr>
          <p:cNvPr id="46" name="TextBox 8"/>
          <p:cNvSpPr/>
          <p:nvPr/>
        </p:nvSpPr>
        <p:spPr>
          <a:xfrm>
            <a:off x="2158560" y="2313000"/>
            <a:ext cx="577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"/>
          <p:cNvSpPr/>
          <p:nvPr/>
        </p:nvSpPr>
        <p:spPr>
          <a:xfrm>
            <a:off x="1536840" y="4734000"/>
            <a:ext cx="71262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In vitro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iofilm formation assays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RG81/ARG81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DAY185)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arg81Δ/Δ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JFY176)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rg81Δ/Δ+pARG81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JFY178)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were performed as described in material and methods.  Photos were taken after 48 hours incubation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4T19:26:00Z</dcterms:created>
  <dc:creator>Jonathan Finkel</dc:creator>
  <dc:description/>
  <dc:language>en-US</dc:language>
  <cp:lastModifiedBy>Aaron Mitchell</cp:lastModifiedBy>
  <dcterms:modified xsi:type="dcterms:W3CDTF">2011-10-21T10:35:36Z</dcterms:modified>
  <cp:revision>3</cp:revision>
  <dc:subject/>
  <dc:title>PowerPoint Presentation</dc:title>
</cp:coreProperties>
</file>